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57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4EC405-3316-41FC-B049-91F463F19D24}" type="datetimeFigureOut">
              <a:rPr lang="en-US" smtClean="0"/>
              <a:pPr/>
              <a:t>9/13/2015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4E9FB-661D-40B9-BFB0-12EA91812928}" type="slidenum">
              <a:rPr lang="en-PH" smtClean="0"/>
              <a:pPr/>
              <a:t>‹#›</a:t>
            </a:fld>
            <a:endParaRPr lang="en-P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228600" y="304800"/>
            <a:ext cx="84720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PH" sz="16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1. Solar </a:t>
            </a:r>
            <a:r>
              <a:rPr lang="en-PH" sz="16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rradiance taken at 7-8 AM, </a:t>
            </a:r>
            <a:r>
              <a:rPr lang="en-PH" sz="16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2-1 </a:t>
            </a:r>
            <a:r>
              <a:rPr lang="en-PH" sz="16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M, and 4-5 PM </a:t>
            </a:r>
            <a:r>
              <a:rPr kumimoji="0" lang="en-PH" sz="16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rom 4 d to 36 d of incubation.</a:t>
            </a:r>
            <a:endParaRPr kumimoji="0" lang="en-PH" sz="16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33400" y="1066800"/>
            <a:ext cx="7991475" cy="4962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14400" y="360222"/>
            <a:ext cx="75438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Enumeration of  </a:t>
            </a:r>
            <a:r>
              <a:rPr lang="en-US" altLang="ja-JP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kane</a:t>
            </a:r>
            <a:r>
              <a:rPr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egraders, and PAH degraders in the dark and light cultures. The values represent single observation based on most probable number method. </a:t>
            </a:r>
            <a:endPara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43000" y="1143000"/>
            <a:ext cx="6896100" cy="519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xmlns="" val="1196552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152400"/>
            <a:ext cx="7391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Degradation of  (A) n-alkanes, (B) pristane and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tane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(C) PAHs and alkylated PAHs  under dark and light conditions (from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cosa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15). The control is sterile water amended with oil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47800" y="1371600"/>
            <a:ext cx="6471920" cy="4667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xmlns="" val="25535352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05000" y="990600"/>
            <a:ext cx="5334000" cy="4933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xmlns="" val="770925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33574" y="969695"/>
            <a:ext cx="5686425" cy="45881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xmlns="" val="3563762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057400" y="608636"/>
            <a:ext cx="4664334" cy="42681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ctangle 4"/>
          <p:cNvSpPr/>
          <p:nvPr/>
        </p:nvSpPr>
        <p:spPr>
          <a:xfrm>
            <a:off x="673331" y="101025"/>
            <a:ext cx="808101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Biplot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diagram of the redundancy analysis (RDA) on bacterial community constrained by sunlight, oil and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Corexit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dispersant.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4572289"/>
            <a:ext cx="7886700" cy="761711"/>
          </a:xfrm>
        </p:spPr>
        <p:txBody>
          <a:bodyPr>
            <a:noAutofit/>
          </a:bodyPr>
          <a:lstStyle/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Table S1. Partial redundancy analysis (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pRD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) to determine how much of variation in microbial community structure is explained by statistically significant variables.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1600200" y="5334000"/>
          <a:ext cx="5329152" cy="13825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00153"/>
                <a:gridCol w="2362200"/>
                <a:gridCol w="1066799"/>
              </a:tblGrid>
              <a:tr h="355970"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Variables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Variation</a:t>
                      </a:r>
                      <a:r>
                        <a:rPr lang="en-PH" sz="16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explained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p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</a:tr>
              <a:tr h="321836"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Light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47%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</a:tr>
              <a:tr h="321836"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Oil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31%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0.004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</a:tr>
              <a:tr h="355970"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Dispersant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21%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r>
                        <a:rPr lang="en-PH" sz="1600" dirty="0" smtClean="0">
                          <a:latin typeface="Times New Roman" pitchFamily="18" charset="0"/>
                          <a:cs typeface="Times New Roman" pitchFamily="18" charset="0"/>
                        </a:rPr>
                        <a:t>0.042</a:t>
                      </a:r>
                      <a:endParaRPr lang="en-PH" sz="16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68580" marR="68580"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228600"/>
            <a:ext cx="85153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PH" sz="1600" dirty="0" smtClean="0">
                <a:latin typeface="Times New Roman" pitchFamily="18" charset="0"/>
                <a:cs typeface="Times New Roman" pitchFamily="18" charset="0"/>
              </a:rPr>
              <a:t>Figure S5. Comparison of the bacterial communities of  dark-oil and light-oil incubations  with field mousse samples (OSS and CT)  collected after the DWH oil spill (Liu and Liu 2013).   </a:t>
            </a:r>
            <a:endParaRPr lang="en-PH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0179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50132" y="838200"/>
            <a:ext cx="6585347" cy="601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810F80663EE4A48816184062C154F03" ma:contentTypeVersion="7" ma:contentTypeDescription="Create a new document." ma:contentTypeScope="" ma:versionID="63c4b1ff8eedc98cb272ca39befa7e13">
  <xsd:schema xmlns:xsd="http://www.w3.org/2001/XMLSchema" xmlns:p="http://schemas.microsoft.com/office/2006/metadata/properties" xmlns:ns2="1a6eac5b-2110-4d64-97e7-57d93c1cfa32" targetNamespace="http://schemas.microsoft.com/office/2006/metadata/properties" ma:root="true" ma:fieldsID="82579d65873cc083acf4514d27052f75" ns2:_="">
    <xsd:import namespace="1a6eac5b-2110-4d64-97e7-57d93c1cfa3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a6eac5b-2110-4d64-97e7-57d93c1cfa3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1a6eac5b-2110-4d64-97e7-57d93c1cfa32">
      <UserInfo>
        <DisplayName/>
        <AccountId xsi:nil="true"/>
        <AccountType/>
      </UserInfo>
    </Checked_x0020_Out_x0020_To>
    <DocumentId xmlns="1a6eac5b-2110-4d64-97e7-57d93c1cfa32">Presentation 1.PPTX</DocumentId>
    <TitleName xmlns="1a6eac5b-2110-4d64-97e7-57d93c1cfa32">Presentation 1.PPTX</TitleName>
    <IsDeleted xmlns="1a6eac5b-2110-4d64-97e7-57d93c1cfa32">false</IsDeleted>
    <FileFormat xmlns="1a6eac5b-2110-4d64-97e7-57d93c1cfa32">PPTX</FileFormat>
    <DocumentType xmlns="1a6eac5b-2110-4d64-97e7-57d93c1cfa32">Presentation</DocumentType>
    <StageName xmlns="1a6eac5b-2110-4d64-97e7-57d93c1cfa32" xsi:nil="true"/>
  </documentManagement>
</p:properties>
</file>

<file path=customXml/itemProps1.xml><?xml version="1.0" encoding="utf-8"?>
<ds:datastoreItem xmlns:ds="http://schemas.openxmlformats.org/officeDocument/2006/customXml" ds:itemID="{3E083D69-C95E-49D9-9ABE-F361CBDB8C84}"/>
</file>

<file path=customXml/itemProps2.xml><?xml version="1.0" encoding="utf-8"?>
<ds:datastoreItem xmlns:ds="http://schemas.openxmlformats.org/officeDocument/2006/customXml" ds:itemID="{B5F05541-9C4D-4CC0-9914-F984D2E76FF8}"/>
</file>

<file path=customXml/itemProps3.xml><?xml version="1.0" encoding="utf-8"?>
<ds:datastoreItem xmlns:ds="http://schemas.openxmlformats.org/officeDocument/2006/customXml" ds:itemID="{9415A042-1DE8-440B-AE27-5FEB18D7A996}"/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202</Words>
  <Application>Microsoft Office PowerPoint</Application>
  <PresentationFormat>On-screen Show (4:3)</PresentationFormat>
  <Paragraphs>18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Table S1. Partial redundancy analysis (pRDA) to determine how much of variation in microbial community structure is explained by statistically significant variables.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User</cp:lastModifiedBy>
  <cp:revision>9</cp:revision>
  <dcterms:created xsi:type="dcterms:W3CDTF">2015-07-01T19:50:43Z</dcterms:created>
  <dcterms:modified xsi:type="dcterms:W3CDTF">2015-09-14T02:52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810F80663EE4A48816184062C154F03</vt:lpwstr>
  </property>
</Properties>
</file>